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2" d="100"/>
          <a:sy n="112" d="100"/>
        </p:scale>
        <p:origin x="51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BioAdmin\OneDrive%20-%20Royal%20Holloway%20University%20of%20London\Desktop\6%20dev%20stages%20carotenoid%20for%20figur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1800" b="1"/>
              <a:t>Chlorophyll</a:t>
            </a:r>
            <a:r>
              <a:rPr lang="en-GB" sz="1800" b="1" baseline="0"/>
              <a:t> a</a:t>
            </a:r>
            <a:endParaRPr lang="en-GB" sz="1800" b="1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chlorophylls  to use'!$C$24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7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hlorophylls  to use'!$D$30:$H$30</c:f>
                <c:numCache>
                  <c:formatCode>General</c:formatCode>
                  <c:ptCount val="5"/>
                  <c:pt idx="0">
                    <c:v>129.43780898123811</c:v>
                  </c:pt>
                  <c:pt idx="1">
                    <c:v>166.80428503004626</c:v>
                  </c:pt>
                  <c:pt idx="2">
                    <c:v>101.86814739906403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hlorophylls  to use'!$D$23:$H$23</c:f>
              <c:strCache>
                <c:ptCount val="5"/>
                <c:pt idx="0">
                  <c:v>25dpa</c:v>
                </c:pt>
                <c:pt idx="1">
                  <c:v>39dpa</c:v>
                </c:pt>
                <c:pt idx="2">
                  <c:v>43dpa</c:v>
                </c:pt>
                <c:pt idx="3">
                  <c:v>49dpa</c:v>
                </c:pt>
                <c:pt idx="4">
                  <c:v>66dpa</c:v>
                </c:pt>
              </c:strCache>
            </c:strRef>
          </c:cat>
          <c:val>
            <c:numRef>
              <c:f>'chlorophylls  to use'!$D$24:$H$24</c:f>
              <c:numCache>
                <c:formatCode>0.0</c:formatCode>
                <c:ptCount val="5"/>
                <c:pt idx="0">
                  <c:v>649.58987306077449</c:v>
                </c:pt>
                <c:pt idx="1">
                  <c:v>534.73916926719687</c:v>
                </c:pt>
                <c:pt idx="2">
                  <c:v>248.9028141137137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</c:ser>
        <c:ser>
          <c:idx val="1"/>
          <c:order val="1"/>
          <c:tx>
            <c:strRef>
              <c:f>'chlorophylls  to use'!$C$25</c:f>
              <c:strCache>
                <c:ptCount val="1"/>
                <c:pt idx="0">
                  <c:v>β-caro. line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hlorophylls  to use'!$D$31:$H$31</c:f>
                <c:numCache>
                  <c:formatCode>General</c:formatCode>
                  <c:ptCount val="5"/>
                  <c:pt idx="0">
                    <c:v>60.68466176213817</c:v>
                  </c:pt>
                  <c:pt idx="1">
                    <c:v>27.807192801060051</c:v>
                  </c:pt>
                  <c:pt idx="2">
                    <c:v>60.425982660688945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hlorophylls  to use'!$D$23:$H$23</c:f>
              <c:strCache>
                <c:ptCount val="5"/>
                <c:pt idx="0">
                  <c:v>25dpa</c:v>
                </c:pt>
                <c:pt idx="1">
                  <c:v>39dpa</c:v>
                </c:pt>
                <c:pt idx="2">
                  <c:v>43dpa</c:v>
                </c:pt>
                <c:pt idx="3">
                  <c:v>49dpa</c:v>
                </c:pt>
                <c:pt idx="4">
                  <c:v>66dpa</c:v>
                </c:pt>
              </c:strCache>
            </c:strRef>
          </c:cat>
          <c:val>
            <c:numRef>
              <c:f>'chlorophylls  to use'!$D$25:$H$25</c:f>
              <c:numCache>
                <c:formatCode>0.0</c:formatCode>
                <c:ptCount val="5"/>
                <c:pt idx="0">
                  <c:v>787.31936523800141</c:v>
                </c:pt>
                <c:pt idx="1">
                  <c:v>647.36404429257857</c:v>
                </c:pt>
                <c:pt idx="2">
                  <c:v>343.84223296320692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</c:ser>
        <c:ser>
          <c:idx val="2"/>
          <c:order val="2"/>
          <c:tx>
            <c:strRef>
              <c:f>'chlorophylls  to use'!$C$26</c:f>
              <c:strCache>
                <c:ptCount val="1"/>
                <c:pt idx="0">
                  <c:v>Keto. line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hlorophylls  to use'!$D$32:$H$32</c:f>
                <c:numCache>
                  <c:formatCode>General</c:formatCode>
                  <c:ptCount val="5"/>
                  <c:pt idx="0">
                    <c:v>42.461891097307529</c:v>
                  </c:pt>
                  <c:pt idx="1">
                    <c:v>50.013490183083825</c:v>
                  </c:pt>
                  <c:pt idx="2">
                    <c:v>79.819237992012319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hlorophylls  to use'!$D$23:$H$23</c:f>
              <c:strCache>
                <c:ptCount val="5"/>
                <c:pt idx="0">
                  <c:v>25dpa</c:v>
                </c:pt>
                <c:pt idx="1">
                  <c:v>39dpa</c:v>
                </c:pt>
                <c:pt idx="2">
                  <c:v>43dpa</c:v>
                </c:pt>
                <c:pt idx="3">
                  <c:v>49dpa</c:v>
                </c:pt>
                <c:pt idx="4">
                  <c:v>66dpa</c:v>
                </c:pt>
              </c:strCache>
            </c:strRef>
          </c:cat>
          <c:val>
            <c:numRef>
              <c:f>'chlorophylls  to use'!$D$26:$H$26</c:f>
              <c:numCache>
                <c:formatCode>0.0</c:formatCode>
                <c:ptCount val="5"/>
                <c:pt idx="0">
                  <c:v>449.83039446268282</c:v>
                </c:pt>
                <c:pt idx="1">
                  <c:v>300.99530720224305</c:v>
                </c:pt>
                <c:pt idx="2">
                  <c:v>91.37278455341476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4112632"/>
        <c:axId val="384124128"/>
      </c:barChart>
      <c:catAx>
        <c:axId val="384112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4124128"/>
        <c:crosses val="autoZero"/>
        <c:auto val="1"/>
        <c:lblAlgn val="ctr"/>
        <c:lblOffset val="100"/>
        <c:noMultiLvlLbl val="0"/>
      </c:catAx>
      <c:valAx>
        <c:axId val="38412412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100" b="1" i="0" baseline="0">
                    <a:effectLst/>
                  </a:rPr>
                  <a:t>µg/g DW</a:t>
                </a:r>
                <a:endParaRPr lang="en-GB" sz="1100">
                  <a:effectLst/>
                </a:endParaRPr>
              </a:p>
            </c:rich>
          </c:tx>
          <c:layout>
            <c:manualLayout>
              <c:xMode val="edge"/>
              <c:yMode val="edge"/>
              <c:x val="2.5000000000000001E-2"/>
              <c:y val="0.3805712306794983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41126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sz="1800" b="1"/>
              <a:t>Chlorophyll</a:t>
            </a:r>
            <a:r>
              <a:rPr lang="en-GB" sz="1800" b="1" baseline="0"/>
              <a:t> b</a:t>
            </a:r>
            <a:endParaRPr lang="en-GB" sz="1800" b="1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chlorophylls  to use'!$C$14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7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hlorophylls  to use'!$D$19:$H$19</c:f>
                <c:numCache>
                  <c:formatCode>General</c:formatCode>
                  <c:ptCount val="5"/>
                  <c:pt idx="0">
                    <c:v>80.149309626044285</c:v>
                  </c:pt>
                  <c:pt idx="1">
                    <c:v>99.632136465723931</c:v>
                  </c:pt>
                  <c:pt idx="2">
                    <c:v>19.319735610990218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hlorophylls  to use'!$D$13:$H$13</c:f>
              <c:strCache>
                <c:ptCount val="5"/>
                <c:pt idx="0">
                  <c:v>25dpa</c:v>
                </c:pt>
                <c:pt idx="1">
                  <c:v>39dpa</c:v>
                </c:pt>
                <c:pt idx="2">
                  <c:v>43dpa</c:v>
                </c:pt>
                <c:pt idx="3">
                  <c:v>49dpa</c:v>
                </c:pt>
                <c:pt idx="4">
                  <c:v>66dpa</c:v>
                </c:pt>
              </c:strCache>
            </c:strRef>
          </c:cat>
          <c:val>
            <c:numRef>
              <c:f>'chlorophylls  to use'!$D$14:$H$14</c:f>
              <c:numCache>
                <c:formatCode>0.0</c:formatCode>
                <c:ptCount val="5"/>
                <c:pt idx="0">
                  <c:v>287.354824276736</c:v>
                </c:pt>
                <c:pt idx="1">
                  <c:v>246.68312402648667</c:v>
                </c:pt>
                <c:pt idx="2">
                  <c:v>161.8638632817879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</c:ser>
        <c:ser>
          <c:idx val="1"/>
          <c:order val="1"/>
          <c:tx>
            <c:strRef>
              <c:f>'chlorophylls  to use'!$C$15</c:f>
              <c:strCache>
                <c:ptCount val="1"/>
                <c:pt idx="0">
                  <c:v>β-caro. line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hlorophylls  to use'!$D$20:$H$20</c:f>
                <c:numCache>
                  <c:formatCode>General</c:formatCode>
                  <c:ptCount val="5"/>
                  <c:pt idx="0">
                    <c:v>34.286381749996181</c:v>
                  </c:pt>
                  <c:pt idx="1">
                    <c:v>99.461324518369352</c:v>
                  </c:pt>
                  <c:pt idx="2">
                    <c:v>27.924838513613668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hlorophylls  to use'!$D$13:$H$13</c:f>
              <c:strCache>
                <c:ptCount val="5"/>
                <c:pt idx="0">
                  <c:v>25dpa</c:v>
                </c:pt>
                <c:pt idx="1">
                  <c:v>39dpa</c:v>
                </c:pt>
                <c:pt idx="2">
                  <c:v>43dpa</c:v>
                </c:pt>
                <c:pt idx="3">
                  <c:v>49dpa</c:v>
                </c:pt>
                <c:pt idx="4">
                  <c:v>66dpa</c:v>
                </c:pt>
              </c:strCache>
            </c:strRef>
          </c:cat>
          <c:val>
            <c:numRef>
              <c:f>'chlorophylls  to use'!$D$15:$H$15</c:f>
              <c:numCache>
                <c:formatCode>0.0</c:formatCode>
                <c:ptCount val="5"/>
                <c:pt idx="0">
                  <c:v>325.91352347448668</c:v>
                </c:pt>
                <c:pt idx="1">
                  <c:v>298.14044994861797</c:v>
                </c:pt>
                <c:pt idx="2">
                  <c:v>133.35589434614496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</c:ser>
        <c:ser>
          <c:idx val="2"/>
          <c:order val="2"/>
          <c:tx>
            <c:strRef>
              <c:f>'chlorophylls  to use'!$C$16</c:f>
              <c:strCache>
                <c:ptCount val="1"/>
                <c:pt idx="0">
                  <c:v>Keto. line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rgbClr val="C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chlorophylls  to use'!$D$21:$H$21</c:f>
                <c:numCache>
                  <c:formatCode>General</c:formatCode>
                  <c:ptCount val="5"/>
                  <c:pt idx="0">
                    <c:v>24.313535010125971</c:v>
                  </c:pt>
                  <c:pt idx="1">
                    <c:v>53.181455963269975</c:v>
                  </c:pt>
                  <c:pt idx="2">
                    <c:v>26.247129524437334</c:v>
                  </c:pt>
                  <c:pt idx="3">
                    <c:v>0</c:v>
                  </c:pt>
                  <c:pt idx="4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hlorophylls  to use'!$D$13:$H$13</c:f>
              <c:strCache>
                <c:ptCount val="5"/>
                <c:pt idx="0">
                  <c:v>25dpa</c:v>
                </c:pt>
                <c:pt idx="1">
                  <c:v>39dpa</c:v>
                </c:pt>
                <c:pt idx="2">
                  <c:v>43dpa</c:v>
                </c:pt>
                <c:pt idx="3">
                  <c:v>49dpa</c:v>
                </c:pt>
                <c:pt idx="4">
                  <c:v>66dpa</c:v>
                </c:pt>
              </c:strCache>
            </c:strRef>
          </c:cat>
          <c:val>
            <c:numRef>
              <c:f>'chlorophylls  to use'!$D$16:$H$16</c:f>
              <c:numCache>
                <c:formatCode>0.0</c:formatCode>
                <c:ptCount val="5"/>
                <c:pt idx="0">
                  <c:v>188.92958031258456</c:v>
                </c:pt>
                <c:pt idx="1">
                  <c:v>105.57492875616776</c:v>
                </c:pt>
                <c:pt idx="2">
                  <c:v>62.079070711158145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4334528"/>
        <c:axId val="384334912"/>
      </c:barChart>
      <c:catAx>
        <c:axId val="3843345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4334912"/>
        <c:crosses val="autoZero"/>
        <c:auto val="1"/>
        <c:lblAlgn val="ctr"/>
        <c:lblOffset val="100"/>
        <c:noMultiLvlLbl val="0"/>
      </c:catAx>
      <c:valAx>
        <c:axId val="384334912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100" b="1"/>
                  <a:t>µg/g DW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43345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B8A32C3-C8C9-4B93-AB58-3CB8637DE23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99E44361-63FC-43E5-B993-D73611BDE4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757ED56D-1B95-4912-8F84-2F32C9129B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86ED-5311-42D7-811F-FB2CA3BA18D7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D09B0675-A1DD-4E5A-87FC-795BE50135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A5E08A31-2646-4793-8E15-F58FB4AC50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20FCC-5820-47F0-9229-D9CDA9055B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7931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1CA8A3EE-ADB8-4257-BECF-B570C28D16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5EFE78EF-D219-4DC9-B0FC-7DE9C39129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AC0EDBE4-0745-402A-9261-A81F0F4A8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86ED-5311-42D7-811F-FB2CA3BA18D7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AE1A329B-2E97-485A-823A-F96D6EE99B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376640E-B1F0-4FCE-9B02-C0BDC0FAC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20FCC-5820-47F0-9229-D9CDA9055B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0484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49DA542F-828B-42B7-897C-86ED9996C6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AB9E683E-C65A-4BE0-9372-8086059B46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7C0F3A5A-E6BA-41F5-ADD2-1D7B24374B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86ED-5311-42D7-811F-FB2CA3BA18D7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E7FCD05-0B84-436A-ACE8-133B2EDBED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D8FE0BA6-036B-4475-8654-62B797A668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20FCC-5820-47F0-9229-D9CDA9055B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4131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56F9915-B1F9-439B-8BF7-702C4FD72C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608AE3DA-361C-4070-A187-49636D30F3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D362F860-982B-4193-AAC3-EB8BFA3DB9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86ED-5311-42D7-811F-FB2CA3BA18D7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29F76E39-3D74-49D0-A1CE-A213059B86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8E4C8DBA-BDA7-4625-A1DB-026B0ACD00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20FCC-5820-47F0-9229-D9CDA9055B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0702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83355C5-2583-4D0B-8834-43F34DC9E9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267624DB-25CC-44A4-964E-9307B40858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DF931E5E-0670-459B-897E-6A0F64BC4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86ED-5311-42D7-811F-FB2CA3BA18D7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C1E41B2F-8087-4799-B0F9-DB29773253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ED37E935-18A1-4AB2-A3CA-A0C0451D02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20FCC-5820-47F0-9229-D9CDA9055B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84274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3ABB1F9-43F7-4102-B21D-32B508ED52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BCFCB409-9941-4655-9842-23CE2F7CB9D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AD188F77-8E57-492A-ABBE-7131AAAD7C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F3DD04F7-4728-4DA7-9628-2414064C5B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86ED-5311-42D7-811F-FB2CA3BA18D7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62DE81E7-852A-49FC-8600-E18399C315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B51F6C73-5E86-4856-8318-27383D142E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20FCC-5820-47F0-9229-D9CDA9055B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6245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35ADEC7-A43D-4217-982E-0234E6B130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47AE89A0-0E10-4274-B06D-C12ACF5695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FB6178BE-6678-4357-941F-A7A27DCEB2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613662AC-D979-4F73-BAD7-38ED4D596A3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8F36341E-99AA-439E-B531-E681F6228D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DA9DB748-EBCF-4199-AD5E-1F11F242E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86ED-5311-42D7-811F-FB2CA3BA18D7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B0C511B2-26DE-45F5-8399-ED0CF0E6A9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B0A8C38F-6940-4158-AF17-AD6F7221C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20FCC-5820-47F0-9229-D9CDA9055B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41386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F99DE74-48F7-4EE5-A1B4-583F084C8D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F83D3646-4EC3-483D-AAB3-8197B2E15C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86ED-5311-42D7-811F-FB2CA3BA18D7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E5CEE267-4886-47F1-B814-ABB798EA46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00A2A782-4B7F-44DA-83F1-6047992018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20FCC-5820-47F0-9229-D9CDA9055B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505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40AA5C9A-C8FE-4C3A-BDAD-52472AF895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86ED-5311-42D7-811F-FB2CA3BA18D7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ABB52EE3-69FA-40F7-9D69-0E41291829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DA8C894B-E625-4DB4-B07A-8EC02C76D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20FCC-5820-47F0-9229-D9CDA9055B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2847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52FCB9C-C100-47CC-BE70-982E73D5E7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CA4352C4-5B6F-43DC-B41C-F8F36AA88F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062BE110-A8D9-4E0A-8922-5800256CA9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9EA43B06-CE66-46B9-BD30-13F43C135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86ED-5311-42D7-811F-FB2CA3BA18D7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8BEE0121-299F-4E5D-8E4B-785D6C292C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7943E44F-4BB6-4ABA-916E-CE67178DD7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20FCC-5820-47F0-9229-D9CDA9055B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08334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5EDE891-93AC-42C3-97B4-50E48EFCAF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934CCDC0-1252-4963-B09C-676020BB68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5CD9B035-0A14-4DA0-8662-29DB10EF84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E96181EA-46C0-4624-9BF4-50536A4EF1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A86ED-5311-42D7-811F-FB2CA3BA18D7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C600BCED-BA41-45F0-81A9-5A9B210A7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4FE639D5-84DD-4D76-B17E-B67CEAC2E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20FCC-5820-47F0-9229-D9CDA9055B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58116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5775B212-0061-49A5-B704-849530C7ED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8B2E9FDD-453B-49A1-BD7E-BA28995EBF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7D9286CC-CCF1-49D7-8A08-79B5894113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BA86ED-5311-42D7-811F-FB2CA3BA18D7}" type="datetimeFigureOut">
              <a:rPr lang="en-GB" smtClean="0"/>
              <a:t>20/10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686D7039-2B39-4EA1-BDF8-B44D485FC0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3F036F0C-1E38-49CB-AD27-09AF3B9603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D20FCC-5820-47F0-9229-D9CDA9055B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0572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9254102" y="614207"/>
            <a:ext cx="180000" cy="1800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Rectangle 4"/>
          <p:cNvSpPr/>
          <p:nvPr/>
        </p:nvSpPr>
        <p:spPr>
          <a:xfrm>
            <a:off x="9254102" y="935499"/>
            <a:ext cx="180000" cy="180000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accent2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Rectangle 5"/>
          <p:cNvSpPr/>
          <p:nvPr/>
        </p:nvSpPr>
        <p:spPr>
          <a:xfrm>
            <a:off x="9254102" y="1256790"/>
            <a:ext cx="180000" cy="180000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TextBox 2"/>
          <p:cNvSpPr txBox="1"/>
          <p:nvPr/>
        </p:nvSpPr>
        <p:spPr>
          <a:xfrm>
            <a:off x="9399245" y="505349"/>
            <a:ext cx="1295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ontrol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9399245" y="847979"/>
            <a:ext cx="20138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 smtClean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GB" dirty="0" smtClean="0"/>
              <a:t>-carotene line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9399245" y="1159307"/>
            <a:ext cx="20138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>
                <a:latin typeface="Calibri" panose="020F0502020204030204" pitchFamily="34" charset="0"/>
                <a:cs typeface="Calibri" panose="020F0502020204030204" pitchFamily="34" charset="0"/>
              </a:rPr>
              <a:t>Keto </a:t>
            </a:r>
            <a:r>
              <a:rPr lang="en-GB" dirty="0" smtClean="0"/>
              <a:t>line</a:t>
            </a:r>
            <a:endParaRPr lang="en-GB" dirty="0"/>
          </a:p>
        </p:txBody>
      </p:sp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2833660"/>
              </p:ext>
            </p:extLst>
          </p:nvPr>
        </p:nvGraphicFramePr>
        <p:xfrm>
          <a:off x="235857" y="44268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6978140"/>
              </p:ext>
            </p:extLst>
          </p:nvPr>
        </p:nvGraphicFramePr>
        <p:xfrm>
          <a:off x="4695371" y="44268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Rectangle 3"/>
          <p:cNvSpPr/>
          <p:nvPr/>
        </p:nvSpPr>
        <p:spPr>
          <a:xfrm>
            <a:off x="460828" y="3634385"/>
            <a:ext cx="9546771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400" dirty="0">
                <a:solidFill>
                  <a:srgbClr val="000000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Figure S3: Chlorophylls content in fruit at different developmental and ripening stages</a:t>
            </a:r>
            <a:endParaRPr lang="en-GB" sz="14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310688" y="1628632"/>
            <a:ext cx="4668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**</a:t>
            </a:r>
            <a:endParaRPr lang="en-GB" sz="1600" dirty="0"/>
          </a:p>
        </p:txBody>
      </p:sp>
      <p:sp>
        <p:nvSpPr>
          <p:cNvPr id="13" name="TextBox 12"/>
          <p:cNvSpPr txBox="1"/>
          <p:nvPr/>
        </p:nvSpPr>
        <p:spPr>
          <a:xfrm>
            <a:off x="2107325" y="1918192"/>
            <a:ext cx="4668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*</a:t>
            </a:r>
            <a:endParaRPr lang="en-GB" sz="1600" dirty="0"/>
          </a:p>
        </p:txBody>
      </p:sp>
      <p:sp>
        <p:nvSpPr>
          <p:cNvPr id="14" name="TextBox 13"/>
          <p:cNvSpPr txBox="1"/>
          <p:nvPr/>
        </p:nvSpPr>
        <p:spPr>
          <a:xfrm>
            <a:off x="2837460" y="2295034"/>
            <a:ext cx="4668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*</a:t>
            </a:r>
            <a:endParaRPr lang="en-GB" sz="1600" dirty="0"/>
          </a:p>
        </p:txBody>
      </p:sp>
      <p:sp>
        <p:nvSpPr>
          <p:cNvPr id="15" name="TextBox 14"/>
          <p:cNvSpPr txBox="1"/>
          <p:nvPr/>
        </p:nvSpPr>
        <p:spPr>
          <a:xfrm>
            <a:off x="5824502" y="1753320"/>
            <a:ext cx="4668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*</a:t>
            </a:r>
            <a:endParaRPr lang="en-GB" sz="1600" dirty="0"/>
          </a:p>
        </p:txBody>
      </p:sp>
      <p:sp>
        <p:nvSpPr>
          <p:cNvPr id="16" name="TextBox 15"/>
          <p:cNvSpPr txBox="1"/>
          <p:nvPr/>
        </p:nvSpPr>
        <p:spPr>
          <a:xfrm>
            <a:off x="6554636" y="1968066"/>
            <a:ext cx="4668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*</a:t>
            </a:r>
            <a:endParaRPr lang="en-GB" sz="1600" dirty="0"/>
          </a:p>
        </p:txBody>
      </p:sp>
      <p:sp>
        <p:nvSpPr>
          <p:cNvPr id="17" name="TextBox 16"/>
          <p:cNvSpPr txBox="1"/>
          <p:nvPr/>
        </p:nvSpPr>
        <p:spPr>
          <a:xfrm>
            <a:off x="7247364" y="2295034"/>
            <a:ext cx="4668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/>
              <a:t>**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4020998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263</TotalTime>
  <Words>33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gueira, Marilise</dc:creator>
  <cp:lastModifiedBy>marilise nogueira</cp:lastModifiedBy>
  <cp:revision>11</cp:revision>
  <dcterms:created xsi:type="dcterms:W3CDTF">2021-09-20T15:33:25Z</dcterms:created>
  <dcterms:modified xsi:type="dcterms:W3CDTF">2022-10-20T15:27:09Z</dcterms:modified>
</cp:coreProperties>
</file>